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1002"/>
    <p:restoredTop sz="96604"/>
  </p:normalViewPr>
  <p:slideViewPr>
    <p:cSldViewPr snapToGrid="0">
      <p:cViewPr varScale="1">
        <p:scale>
          <a:sx n="94" d="100"/>
          <a:sy n="94" d="100"/>
        </p:scale>
        <p:origin x="1216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8092F-CFE5-7348-A7EF-C5680131CA6C}" type="datetimeFigureOut">
              <a:rPr lang="en-US" smtClean="0"/>
              <a:t>8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F0C3D-29DD-584E-8395-51FCBD8D6D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89139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8092F-CFE5-7348-A7EF-C5680131CA6C}" type="datetimeFigureOut">
              <a:rPr lang="en-US" smtClean="0"/>
              <a:t>8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F0C3D-29DD-584E-8395-51FCBD8D6D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44735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3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3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8092F-CFE5-7348-A7EF-C5680131CA6C}" type="datetimeFigureOut">
              <a:rPr lang="en-US" smtClean="0"/>
              <a:t>8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F0C3D-29DD-584E-8395-51FCBD8D6D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95449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8092F-CFE5-7348-A7EF-C5680131CA6C}" type="datetimeFigureOut">
              <a:rPr lang="en-US" smtClean="0"/>
              <a:t>8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F0C3D-29DD-584E-8395-51FCBD8D6D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40377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8092F-CFE5-7348-A7EF-C5680131CA6C}" type="datetimeFigureOut">
              <a:rPr lang="en-US" smtClean="0"/>
              <a:t>8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F0C3D-29DD-584E-8395-51FCBD8D6D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27292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8092F-CFE5-7348-A7EF-C5680131CA6C}" type="datetimeFigureOut">
              <a:rPr lang="en-US" smtClean="0"/>
              <a:t>8/2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F0C3D-29DD-584E-8395-51FCBD8D6D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51965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5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8092F-CFE5-7348-A7EF-C5680131CA6C}" type="datetimeFigureOut">
              <a:rPr lang="en-US" smtClean="0"/>
              <a:t>8/28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F0C3D-29DD-584E-8395-51FCBD8D6D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39799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8092F-CFE5-7348-A7EF-C5680131CA6C}" type="datetimeFigureOut">
              <a:rPr lang="en-US" smtClean="0"/>
              <a:t>8/28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F0C3D-29DD-584E-8395-51FCBD8D6D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45677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8092F-CFE5-7348-A7EF-C5680131CA6C}" type="datetimeFigureOut">
              <a:rPr lang="en-US" smtClean="0"/>
              <a:t>8/28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F0C3D-29DD-584E-8395-51FCBD8D6D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46322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8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8092F-CFE5-7348-A7EF-C5680131CA6C}" type="datetimeFigureOut">
              <a:rPr lang="en-US" smtClean="0"/>
              <a:t>8/2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F0C3D-29DD-584E-8395-51FCBD8D6D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21146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8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8092F-CFE5-7348-A7EF-C5680131CA6C}" type="datetimeFigureOut">
              <a:rPr lang="en-US" smtClean="0"/>
              <a:t>8/2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F0C3D-29DD-584E-8395-51FCBD8D6D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06530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5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D8092F-CFE5-7348-A7EF-C5680131CA6C}" type="datetimeFigureOut">
              <a:rPr lang="en-US" smtClean="0"/>
              <a:t>8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EF0C3D-29DD-584E-8395-51FCBD8D6D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0390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2E0E235F-3D34-70E9-2A75-AF5CA2D430B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3457" y="612225"/>
            <a:ext cx="4517410" cy="2185286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0C5DAA37-E396-3CCB-7E86-2719B84DD47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87102" y="2910896"/>
            <a:ext cx="4503765" cy="2190382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5D74B9B6-1762-BCE1-7735-7486337A8E2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87102" y="5214664"/>
            <a:ext cx="4503765" cy="2186065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269DD031-271C-9833-40E3-95F56C0C5DB2}"/>
              </a:ext>
            </a:extLst>
          </p:cNvPr>
          <p:cNvSpPr txBox="1"/>
          <p:nvPr/>
        </p:nvSpPr>
        <p:spPr>
          <a:xfrm>
            <a:off x="1405467" y="569890"/>
            <a:ext cx="712054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S100a8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55EAEFC-E90A-556A-6DB2-BDE94EB5420F}"/>
              </a:ext>
            </a:extLst>
          </p:cNvPr>
          <p:cNvSpPr txBox="1"/>
          <p:nvPr/>
        </p:nvSpPr>
        <p:spPr>
          <a:xfrm>
            <a:off x="2844801" y="569890"/>
            <a:ext cx="712054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S100a9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EFF39E8-5179-BF74-5D80-0B751F1DBC07}"/>
              </a:ext>
            </a:extLst>
          </p:cNvPr>
          <p:cNvSpPr txBox="1"/>
          <p:nvPr/>
        </p:nvSpPr>
        <p:spPr>
          <a:xfrm>
            <a:off x="4464604" y="569889"/>
            <a:ext cx="551754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Vcan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9F828E5-4CEA-B214-775E-8FFCF59A09AB}"/>
              </a:ext>
            </a:extLst>
          </p:cNvPr>
          <p:cNvSpPr txBox="1"/>
          <p:nvPr/>
        </p:nvSpPr>
        <p:spPr>
          <a:xfrm>
            <a:off x="4419495" y="2843359"/>
            <a:ext cx="641971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Trem2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822C9C7-B9DC-100B-F9D2-4BF8525F48E7}"/>
              </a:ext>
            </a:extLst>
          </p:cNvPr>
          <p:cNvSpPr txBox="1"/>
          <p:nvPr/>
        </p:nvSpPr>
        <p:spPr>
          <a:xfrm>
            <a:off x="2898501" y="2843359"/>
            <a:ext cx="604653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Lgmn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CC287D3-0F5E-05E2-4D59-5A125AB028AC}"/>
              </a:ext>
            </a:extLst>
          </p:cNvPr>
          <p:cNvSpPr txBox="1"/>
          <p:nvPr/>
        </p:nvSpPr>
        <p:spPr>
          <a:xfrm>
            <a:off x="1412773" y="2837846"/>
            <a:ext cx="569387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Apoe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6490D91-E020-E06B-65DB-77EFACC65C11}"/>
              </a:ext>
            </a:extLst>
          </p:cNvPr>
          <p:cNvSpPr txBox="1"/>
          <p:nvPr/>
        </p:nvSpPr>
        <p:spPr>
          <a:xfrm>
            <a:off x="1459969" y="5168815"/>
            <a:ext cx="60305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Gzm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5900AC4-D3D5-8ABA-18E3-D38AFCF6A251}"/>
              </a:ext>
            </a:extLst>
          </p:cNvPr>
          <p:cNvSpPr txBox="1"/>
          <p:nvPr/>
        </p:nvSpPr>
        <p:spPr>
          <a:xfrm>
            <a:off x="2943385" y="5168815"/>
            <a:ext cx="559769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Cd69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F567849-1A60-818F-5AD8-151B53845479}"/>
              </a:ext>
            </a:extLst>
          </p:cNvPr>
          <p:cNvSpPr txBox="1"/>
          <p:nvPr/>
        </p:nvSpPr>
        <p:spPr>
          <a:xfrm>
            <a:off x="4485087" y="5168815"/>
            <a:ext cx="534121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Ror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FE0E036-B8D5-2ABC-82A8-A525E9202A90}"/>
              </a:ext>
            </a:extLst>
          </p:cNvPr>
          <p:cNvSpPr txBox="1"/>
          <p:nvPr/>
        </p:nvSpPr>
        <p:spPr>
          <a:xfrm>
            <a:off x="678187" y="544688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0CB1130-4F81-6436-1656-E38F848C4293}"/>
              </a:ext>
            </a:extLst>
          </p:cNvPr>
          <p:cNvSpPr txBox="1"/>
          <p:nvPr/>
        </p:nvSpPr>
        <p:spPr>
          <a:xfrm>
            <a:off x="678187" y="2781090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A86B3D4-EF02-0677-E20C-A980C26BC313}"/>
              </a:ext>
            </a:extLst>
          </p:cNvPr>
          <p:cNvSpPr txBox="1"/>
          <p:nvPr/>
        </p:nvSpPr>
        <p:spPr>
          <a:xfrm>
            <a:off x="678187" y="5147127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71960CD-4BF9-26A5-1252-19D6F93F00A7}"/>
              </a:ext>
            </a:extLst>
          </p:cNvPr>
          <p:cNvSpPr txBox="1"/>
          <p:nvPr/>
        </p:nvSpPr>
        <p:spPr>
          <a:xfrm>
            <a:off x="678187" y="7662477"/>
            <a:ext cx="5622601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l Figure 6.  </a:t>
            </a:r>
            <a:r>
              <a:rPr lang="en-US" sz="14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Visualization of gene expression in murine cholestatic macrophage clusters by etiology of previously identified genes from human monocyte-like macrophages (</a:t>
            </a:r>
            <a:r>
              <a:rPr lang="en-US" sz="14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</a:t>
            </a:r>
            <a:r>
              <a:rPr lang="en-US" sz="14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, lipid associated macrophages (</a:t>
            </a:r>
            <a:r>
              <a:rPr lang="en-US" sz="14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</a:t>
            </a:r>
            <a:r>
              <a:rPr lang="en-US" sz="14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, and adaptive macrophages (</a:t>
            </a:r>
            <a:r>
              <a:rPr lang="en-US" sz="14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</a:t>
            </a:r>
            <a:r>
              <a:rPr lang="en-US" sz="14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.</a:t>
            </a:r>
            <a:endParaRPr lang="en-US" sz="14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grpSp>
        <p:nvGrpSpPr>
          <p:cNvPr id="22" name="Group 21">
            <a:extLst>
              <a:ext uri="{FF2B5EF4-FFF2-40B4-BE49-F238E27FC236}">
                <a16:creationId xmlns:a16="http://schemas.microsoft.com/office/drawing/2014/main" id="{F66035B1-A2A1-2AF3-5B89-D6D6DC966043}"/>
              </a:ext>
            </a:extLst>
          </p:cNvPr>
          <p:cNvGrpSpPr/>
          <p:nvPr/>
        </p:nvGrpSpPr>
        <p:grpSpPr>
          <a:xfrm>
            <a:off x="5311235" y="566376"/>
            <a:ext cx="709438" cy="464385"/>
            <a:chOff x="5524657" y="349333"/>
            <a:chExt cx="709438" cy="464385"/>
          </a:xfrm>
        </p:grpSpPr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E4B5C3B1-D890-80C5-1DF9-B989FC0733C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45652" t="40527" r="46087" b="43029"/>
            <a:stretch/>
          </p:blipFill>
          <p:spPr>
            <a:xfrm>
              <a:off x="5524657" y="349333"/>
              <a:ext cx="335348" cy="464385"/>
            </a:xfrm>
            <a:prstGeom prst="rect">
              <a:avLst/>
            </a:prstGeom>
          </p:spPr>
        </p:pic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6690691F-9B87-7749-64C8-EC85A8B66F62}"/>
                </a:ext>
              </a:extLst>
            </p:cNvPr>
            <p:cNvSpPr txBox="1"/>
            <p:nvPr/>
          </p:nvSpPr>
          <p:spPr>
            <a:xfrm>
              <a:off x="5778521" y="381043"/>
              <a:ext cx="43313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BDL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6263CC0F-17BF-497C-6D12-873089951FA0}"/>
                </a:ext>
              </a:extLst>
            </p:cNvPr>
            <p:cNvSpPr txBox="1"/>
            <p:nvPr/>
          </p:nvSpPr>
          <p:spPr>
            <a:xfrm>
              <a:off x="5778521" y="535904"/>
              <a:ext cx="45557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RRV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8314880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50</TotalTime>
  <Words>55</Words>
  <Application>Microsoft Macintosh PowerPoint</Application>
  <PresentationFormat>Letter Paper (8.5x11 in)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ylor, Sarah 2</dc:creator>
  <cp:lastModifiedBy>Taylor, Sarah 2</cp:lastModifiedBy>
  <cp:revision>4</cp:revision>
  <dcterms:created xsi:type="dcterms:W3CDTF">2023-08-09T11:43:27Z</dcterms:created>
  <dcterms:modified xsi:type="dcterms:W3CDTF">2023-08-28T11:44:29Z</dcterms:modified>
</cp:coreProperties>
</file>